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9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34AC6-8088-439A-A3E1-58ED1A81CA5B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2FE34-8B0E-403C-B40F-F88E69E9AC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43726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34AC6-8088-439A-A3E1-58ED1A81CA5B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2FE34-8B0E-403C-B40F-F88E69E9AC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1572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34AC6-8088-439A-A3E1-58ED1A81CA5B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2FE34-8B0E-403C-B40F-F88E69E9AC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3956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34AC6-8088-439A-A3E1-58ED1A81CA5B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2FE34-8B0E-403C-B40F-F88E69E9AC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6934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34AC6-8088-439A-A3E1-58ED1A81CA5B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2FE34-8B0E-403C-B40F-F88E69E9AC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39602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34AC6-8088-439A-A3E1-58ED1A81CA5B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2FE34-8B0E-403C-B40F-F88E69E9AC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93458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34AC6-8088-439A-A3E1-58ED1A81CA5B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2FE34-8B0E-403C-B40F-F88E69E9AC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66352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34AC6-8088-439A-A3E1-58ED1A81CA5B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2FE34-8B0E-403C-B40F-F88E69E9AC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54252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34AC6-8088-439A-A3E1-58ED1A81CA5B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2FE34-8B0E-403C-B40F-F88E69E9AC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71854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34AC6-8088-439A-A3E1-58ED1A81CA5B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2FE34-8B0E-403C-B40F-F88E69E9AC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4464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34AC6-8088-439A-A3E1-58ED1A81CA5B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2FE34-8B0E-403C-B40F-F88E69E9AC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99520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B34AC6-8088-439A-A3E1-58ED1A81CA5B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62FE34-8B0E-403C-B40F-F88E69E9AC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7455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55611186"/>
              </p:ext>
            </p:extLst>
          </p:nvPr>
        </p:nvGraphicFramePr>
        <p:xfrm>
          <a:off x="0" y="404664"/>
          <a:ext cx="9150035" cy="405483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15642"/>
                <a:gridCol w="51902"/>
                <a:gridCol w="792926"/>
                <a:gridCol w="1053842"/>
                <a:gridCol w="1467079"/>
                <a:gridCol w="508876"/>
                <a:gridCol w="1115352"/>
                <a:gridCol w="864096"/>
                <a:gridCol w="444391"/>
                <a:gridCol w="851753"/>
                <a:gridCol w="216024"/>
                <a:gridCol w="216024"/>
                <a:gridCol w="360040"/>
                <a:gridCol w="792088"/>
              </a:tblGrid>
              <a:tr h="2880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 Patient 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Gross 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Initial diagnosis on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FIGO 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Final </a:t>
                      </a:r>
                      <a:r>
                        <a:rPr lang="en-US" sz="900" b="1" u="none" strike="noStrike" dirty="0" err="1">
                          <a:effectLst/>
                        </a:rPr>
                        <a:t>dignosis</a:t>
                      </a:r>
                      <a:r>
                        <a:rPr lang="en-US" sz="900" b="1" u="none" strike="noStrike" dirty="0">
                          <a:effectLst/>
                        </a:rPr>
                        <a:t> on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Depth of 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 err="1">
                          <a:effectLst/>
                        </a:rPr>
                        <a:t>Lymphovascular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T 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N 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M 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Recurrence and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557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No.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900" b="1" i="0" u="none" strike="noStrike" dirty="0" smtClean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  <a:p>
                      <a:pPr algn="ctr" fontAlgn="ctr"/>
                      <a:r>
                        <a:rPr lang="ja-JP" altLang="en-US" sz="900" b="1" u="none" strike="noStrike" dirty="0">
                          <a:effectLst/>
                        </a:rPr>
                        <a:t>　</a:t>
                      </a:r>
                      <a:endParaRPr lang="ja-JP" alt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1" u="none" strike="noStrike" dirty="0" smtClean="0">
                          <a:effectLst/>
                        </a:rPr>
                        <a:t>appearance</a:t>
                      </a:r>
                      <a:endParaRPr lang="en-US" altLang="ja-JP" sz="900" b="1" i="0" u="none" strike="noStrike" dirty="0" smtClean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  <a:p>
                      <a:pPr algn="ctr" fontAlgn="ctr"/>
                      <a:r>
                        <a:rPr lang="ja-JP" altLang="en-US" sz="900" b="1" u="none" strike="noStrike" dirty="0">
                          <a:effectLst/>
                        </a:rPr>
                        <a:t>　</a:t>
                      </a:r>
                      <a:endParaRPr lang="ja-JP" alt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 err="1">
                          <a:effectLst/>
                        </a:rPr>
                        <a:t>colposcopicl</a:t>
                      </a:r>
                      <a:r>
                        <a:rPr lang="en-US" sz="900" b="1" u="none" strike="noStrike" dirty="0">
                          <a:effectLst/>
                        </a:rPr>
                        <a:t> selective  biopsy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1" u="none" strike="noStrike" dirty="0" smtClean="0">
                          <a:effectLst/>
                        </a:rPr>
                        <a:t>MRI findings</a:t>
                      </a:r>
                      <a:endParaRPr lang="en-US" altLang="ja-JP" sz="900" b="1" i="0" u="none" strike="noStrike" dirty="0" smtClean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  <a:p>
                      <a:pPr algn="ctr" fontAlgn="ctr"/>
                      <a:r>
                        <a:rPr lang="ja-JP" altLang="en-US" sz="900" b="1" u="none" strike="noStrike" dirty="0">
                          <a:effectLst/>
                        </a:rPr>
                        <a:t>　</a:t>
                      </a:r>
                      <a:endParaRPr lang="ja-JP" alt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 dirty="0" smtClean="0">
                          <a:effectLst/>
                        </a:rPr>
                        <a:t>stage</a:t>
                      </a:r>
                      <a:r>
                        <a:rPr lang="ja-JP" altLang="en-US" sz="900" b="1" u="none" strike="noStrike" dirty="0">
                          <a:effectLst/>
                        </a:rPr>
                        <a:t>　</a:t>
                      </a:r>
                      <a:endParaRPr lang="ja-JP" alt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1" u="none" strike="noStrike" dirty="0" smtClean="0">
                          <a:effectLst/>
                        </a:rPr>
                        <a:t>Treatment(s) *)</a:t>
                      </a:r>
                      <a:endParaRPr lang="en-US" altLang="ja-JP" sz="900" b="1" i="0" u="none" strike="noStrike" dirty="0" smtClean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  <a:p>
                      <a:pPr algn="ctr" fontAlgn="ctr"/>
                      <a:r>
                        <a:rPr lang="ja-JP" altLang="en-US" sz="900" b="1" u="none" strike="noStrike" dirty="0">
                          <a:effectLst/>
                        </a:rPr>
                        <a:t>　</a:t>
                      </a:r>
                      <a:endParaRPr lang="ja-JP" alt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surgical specimen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invasion (mm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space invasion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 dirty="0" smtClean="0">
                          <a:effectLst/>
                        </a:rPr>
                        <a:t>**)</a:t>
                      </a:r>
                      <a:r>
                        <a:rPr lang="ja-JP" altLang="en-US" sz="900" b="1" u="none" strike="noStrike" dirty="0">
                          <a:effectLst/>
                        </a:rPr>
                        <a:t>　</a:t>
                      </a:r>
                      <a:endParaRPr lang="ja-JP" alt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1" u="none" strike="noStrike" dirty="0" smtClean="0">
                          <a:effectLst/>
                        </a:rPr>
                        <a:t>       **)</a:t>
                      </a:r>
                      <a:endParaRPr lang="en-US" altLang="ja-JP" sz="900" b="1" i="0" u="none" strike="noStrike" dirty="0" smtClean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  <a:p>
                      <a:pPr algn="ctr" fontAlgn="ctr"/>
                      <a:r>
                        <a:rPr lang="ja-JP" altLang="en-US" sz="900" b="1" u="none" strike="noStrike" dirty="0">
                          <a:effectLst/>
                        </a:rPr>
                        <a:t>　</a:t>
                      </a:r>
                      <a:endParaRPr lang="ja-JP" alt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1" u="none" strike="noStrike" baseline="0" dirty="0" smtClean="0">
                          <a:effectLst/>
                        </a:rPr>
                        <a:t>          </a:t>
                      </a:r>
                      <a:r>
                        <a:rPr lang="en-US" altLang="ja-JP" sz="900" b="1" u="none" strike="noStrike" dirty="0" smtClean="0">
                          <a:effectLst/>
                        </a:rPr>
                        <a:t>**)</a:t>
                      </a:r>
                      <a:endParaRPr lang="en-US" altLang="ja-JP" sz="900" b="1" i="0" u="none" strike="noStrike" dirty="0" smtClean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  <a:p>
                      <a:pPr algn="ctr" fontAlgn="ctr"/>
                      <a:r>
                        <a:rPr lang="ja-JP" altLang="en-US" sz="900" b="1" u="none" strike="noStrike" dirty="0">
                          <a:effectLst/>
                        </a:rPr>
                        <a:t>　</a:t>
                      </a:r>
                      <a:endParaRPr lang="ja-JP" alt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rognosis ***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5575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1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erosion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PSCC, invasion (-)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no apparent mass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CIS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conization + LH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SCC, non-invasiv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-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Tis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-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21M no recurrenc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5575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2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apillary lesion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PSCC, invasion (-)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no apparent mass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IB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conization + LH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SCC, non-invasiv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-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T1b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-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35M no recurrenc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5575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3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wart-lik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PSCC, invasion: ambiguous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no apparent mass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IB1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RH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SCC, non-invasiv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-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T1b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73M no recurrenc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5575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4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olypoid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SCC, invasion: ambiguous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no apparent mass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IB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RH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SCC, non-invasiv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-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T1b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66M no recurrenc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5575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5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wart-lik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SCC, invasion (+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no apparent mass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IB1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RH + chemo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SCC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1.5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+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T1b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68M no recurrenc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5575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6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olypoid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SCC, invasion (-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papillary growing, invasion (-)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IB1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RH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SCC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1.8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-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T1b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25M no recurrenc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5575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7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apillary lesion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SCC, invasion (+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no apparent mass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IB1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RH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SCC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3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-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T1b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82M no recurrenc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5575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8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exophytic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SCC, invasion (+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apillary growing, invasion (+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IIA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RH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SCC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3.1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-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T2a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54M no recurrenc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5575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9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exophytic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SCC, invasion: ambiguous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27X15mm mass, invasion (+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IB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RH + chemo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PSCC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 dirty="0">
                          <a:effectLst/>
                        </a:rPr>
                        <a:t>9</a:t>
                      </a:r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+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T1b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37M no recurrenc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5575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1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exophytic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SCC, invasion: ambiguous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41mm, mass, invasion (+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IB2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radical trachelectomy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SCC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12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 dirty="0">
                          <a:effectLst/>
                        </a:rPr>
                        <a:t>-</a:t>
                      </a:r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T1b2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43M no recurrenc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5575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11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exophytic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SCC, invasion (+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39X45mm, invasion (+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IB2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RH + chemo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SCC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35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+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T2a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 dirty="0">
                          <a:effectLst/>
                        </a:rPr>
                        <a:t>0</a:t>
                      </a:r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7M no recurrenc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5575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12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exophytic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SCC, invasion (+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apillary growing, invasion (+) bil paramet (+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IIB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chemo + RH + radiation + chemo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PSCC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27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-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yT2b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y0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y0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79M no recurrenc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4883" marR="4883" marT="488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</a:tbl>
          </a:graphicData>
        </a:graphic>
      </p:graphicFrame>
      <p:cxnSp>
        <p:nvCxnSpPr>
          <p:cNvPr id="6" name="直線コネクタ 5"/>
          <p:cNvCxnSpPr/>
          <p:nvPr/>
        </p:nvCxnSpPr>
        <p:spPr>
          <a:xfrm>
            <a:off x="0" y="1110005"/>
            <a:ext cx="914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0" y="4640690"/>
            <a:ext cx="554376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/>
              <a:t>Table </a:t>
            </a:r>
            <a:r>
              <a:rPr lang="en-US" altLang="ja-JP" sz="1200" b="1" smtClean="0"/>
              <a:t> S1</a:t>
            </a:r>
            <a:r>
              <a:rPr lang="en-US" altLang="ja-JP" sz="1200" b="1" dirty="0"/>
              <a:t>. </a:t>
            </a:r>
            <a:r>
              <a:rPr lang="en-US" altLang="ja-JP" sz="1200" dirty="0"/>
              <a:t>The </a:t>
            </a:r>
            <a:r>
              <a:rPr lang="en-US" altLang="ja-JP" sz="1200" dirty="0" err="1"/>
              <a:t>clinicopathological</a:t>
            </a:r>
            <a:r>
              <a:rPr lang="en-US" altLang="ja-JP" sz="1200" dirty="0"/>
              <a:t> data of the 12 true PSCC patients. </a:t>
            </a:r>
            <a:endParaRPr lang="en-US" altLang="ja-JP" sz="1200" dirty="0" smtClean="0"/>
          </a:p>
          <a:p>
            <a:r>
              <a:rPr lang="en-US" altLang="ja-JP" sz="1200" dirty="0"/>
              <a:t>*) LH = laparoscopic hysterectomy, RH = radical hysterectomy, chemo = </a:t>
            </a:r>
            <a:r>
              <a:rPr lang="en-US" altLang="ja-JP" sz="1200" dirty="0" smtClean="0"/>
              <a:t>chemotherapy</a:t>
            </a:r>
          </a:p>
          <a:p>
            <a:r>
              <a:rPr lang="en-US" altLang="ja-JP" sz="1200" dirty="0"/>
              <a:t>**) "y" indicates a performance of preoperative treatment</a:t>
            </a:r>
            <a:r>
              <a:rPr lang="en-US" altLang="ja-JP" sz="1200" dirty="0" smtClean="0"/>
              <a:t>.</a:t>
            </a:r>
          </a:p>
          <a:p>
            <a:r>
              <a:rPr lang="en-US" altLang="ja-JP" sz="1200" dirty="0"/>
              <a:t>***) M = months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196435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373</Words>
  <Application>Microsoft Office PowerPoint</Application>
  <PresentationFormat>画面に合わせる (4:3)</PresentationFormat>
  <Paragraphs>19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越山雅文</dc:creator>
  <cp:lastModifiedBy>越山雅文</cp:lastModifiedBy>
  <cp:revision>7</cp:revision>
  <dcterms:created xsi:type="dcterms:W3CDTF">2014-09-20T09:47:07Z</dcterms:created>
  <dcterms:modified xsi:type="dcterms:W3CDTF">2014-11-05T00:15:29Z</dcterms:modified>
</cp:coreProperties>
</file>